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67B6DC4-57DA-45BC-A61A-10FD79DF1BA1}" type="slidenum">
              <a:rPr b="0" lang="en-GB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istribu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369F93-F5E6-4721-BA61-A7691C6226E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E8DC62-1165-487D-A192-63D9204866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A21D0E-A0AC-4D8F-8823-C9F59352FED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5E82F8-6012-4CA4-9511-294884423C3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FDD66D-8542-4F77-93EB-38B174DC7A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DD6A71-29A4-4E3F-A5FF-2D70937CA7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30ACFB-9C3B-41D3-95B2-3FF557F3A6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295852-20CC-4DD0-8AC1-BA9F0B31C9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8B22DB-C2AA-418F-9187-02D62D35A9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081998-591D-4547-8A2C-6400E91F98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D68DB9-2D9F-4090-801D-574B8589DB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4CAC59-564D-469F-BC95-48CE2A9541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29F1790-2937-4E56-B1AB-79081A7570A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774720" y="968400"/>
          <a:ext cx="7461360" cy="55306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9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74720" y="968400"/>
                    <a:ext cx="7461360" cy="5530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0" name=""/>
          <p:cNvSpPr/>
          <p:nvPr/>
        </p:nvSpPr>
        <p:spPr>
          <a:xfrm>
            <a:off x="4336920" y="1847880"/>
            <a:ext cx="4692960" cy="222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42 clusters containing 10 or more reads, most of them are house –keeping genes (17 ribosomal proteins, 10 cytoskeleton proteins, 2 elongation factors and 7 other proteins). 6 clusters show no matches.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776760" y="1743120"/>
            <a:ext cx="0" cy="4201920"/>
          </a:xfrm>
          <a:prstGeom prst="line">
            <a:avLst/>
          </a:prstGeom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3780000" y="2549520"/>
            <a:ext cx="574560" cy="0"/>
          </a:xfrm>
          <a:prstGeom prst="line">
            <a:avLst/>
          </a:prstGeom>
          <a:ln w="7632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7742520" y="5737320"/>
            <a:ext cx="26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0-14T14:51:15Z</dcterms:created>
  <dc:creator>Tokiharu Takahashi</dc:creator>
  <dc:description/>
  <dc:language>en-US</dc:language>
  <cp:lastModifiedBy>Tokiharu Takahashi</cp:lastModifiedBy>
  <dcterms:modified xsi:type="dcterms:W3CDTF">2009-09-02T16:05:24Z</dcterms:modified>
  <cp:revision>12</cp:revision>
  <dc:subject/>
  <dc:title>Slide 1</dc:title>
</cp:coreProperties>
</file>